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2CB97-853A-4C69-9045-1F2E6C9240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136AA-63D0-4400-B272-227DB0BB73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14537-0B3A-4B4F-AE31-DDC78B8835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A0B1F-D0F5-4712-B5FB-3A52BF9AD4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4350A-C1A3-4979-8C75-27433D2F8B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94B24-D2C9-46F8-B7C3-83BD6FA29A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D64DA-5ED1-4DF0-BF3D-B19817DE6A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3A9B1-3F1A-4B95-B476-E3F8A68E2D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58D26-1218-40D9-82BE-BC234CDE6F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696AF-2379-47B4-8AFE-73D6EA3DC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C001F-D9CE-4C3C-9070-195D4BD837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27380-E2CA-432F-861F-064A479F8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67FA5C-0FCA-497E-8AC1-B2BA31EFB250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1 Gráfico" descr=""/>
          <p:cNvPicPr/>
          <p:nvPr/>
        </p:nvPicPr>
        <p:blipFill>
          <a:blip r:embed="rId1"/>
          <a:stretch/>
        </p:blipFill>
        <p:spPr>
          <a:xfrm>
            <a:off x="-66600" y="1298520"/>
            <a:ext cx="7284960" cy="5407200"/>
          </a:xfrm>
          <a:prstGeom prst="rect">
            <a:avLst/>
          </a:prstGeom>
          <a:ln w="0">
            <a:noFill/>
          </a:ln>
        </p:spPr>
      </p:pic>
      <p:sp>
        <p:nvSpPr>
          <p:cNvPr id="42" name="2 Rectángulo"/>
          <p:cNvSpPr/>
          <p:nvPr/>
        </p:nvSpPr>
        <p:spPr>
          <a:xfrm>
            <a:off x="0" y="6837480"/>
            <a:ext cx="6858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unctional assignment of metagenomic sequences using BLASTX against NCBI-nr. The data was analyzed using MEGAN v4.0 software and KEGG identifiers.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6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9T01:32:11Z</dcterms:created>
  <dc:creator>Fernando Andreote</dc:creator>
  <dc:description/>
  <dc:language>en-US</dc:language>
  <cp:lastModifiedBy>D.J. Jimenez Avella</cp:lastModifiedBy>
  <dcterms:modified xsi:type="dcterms:W3CDTF">2012-11-16T15:48:18Z</dcterms:modified>
  <cp:revision>323</cp:revision>
  <dc:subject/>
  <dc:title>Slide 1</dc:title>
</cp:coreProperties>
</file>